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8" r:id="rId2"/>
  </p:sldIdLst>
  <p:sldSz cx="18216563" cy="13716000"/>
  <p:notesSz cx="6858000" cy="9144000"/>
  <p:defaultTextStyle>
    <a:defPPr>
      <a:defRPr lang="zh-TW"/>
    </a:defPPr>
    <a:lvl1pPr marL="0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1pPr>
    <a:lvl2pPr marL="659282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2pPr>
    <a:lvl3pPr marL="1318565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3pPr>
    <a:lvl4pPr marL="1977847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4pPr>
    <a:lvl5pPr marL="2637130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5pPr>
    <a:lvl6pPr marL="3296412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6pPr>
    <a:lvl7pPr marL="3955694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7pPr>
    <a:lvl8pPr marL="4614977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8pPr>
    <a:lvl9pPr marL="5274259" algn="l" defTabSz="1318565" rtl="0" eaLnBrk="1" latinLnBrk="0" hangingPunct="1">
      <a:defRPr sz="259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0" userDrawn="1">
          <p15:clr>
            <a:srgbClr val="A4A3A4"/>
          </p15:clr>
        </p15:guide>
        <p15:guide id="2" pos="57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3320"/>
    <p:restoredTop sz="95304"/>
  </p:normalViewPr>
  <p:slideViewPr>
    <p:cSldViewPr snapToGrid="0" snapToObjects="1" showGuides="1">
      <p:cViewPr>
        <p:scale>
          <a:sx n="56" d="100"/>
          <a:sy n="56" d="100"/>
        </p:scale>
        <p:origin x="184" y="-224"/>
      </p:cViewPr>
      <p:guideLst>
        <p:guide orient="horz" pos="4320"/>
        <p:guide pos="57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66242" y="2244726"/>
            <a:ext cx="15484079" cy="4775200"/>
          </a:xfrm>
        </p:spPr>
        <p:txBody>
          <a:bodyPr anchor="b"/>
          <a:lstStyle>
            <a:lvl1pPr algn="ctr">
              <a:defRPr sz="11953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77071" y="7204076"/>
            <a:ext cx="13662422" cy="3311524"/>
          </a:xfrm>
        </p:spPr>
        <p:txBody>
          <a:bodyPr/>
          <a:lstStyle>
            <a:lvl1pPr marL="0" indent="0" algn="ctr">
              <a:buNone/>
              <a:defRPr sz="4781"/>
            </a:lvl1pPr>
            <a:lvl2pPr marL="910834" indent="0" algn="ctr">
              <a:buNone/>
              <a:defRPr sz="3984"/>
            </a:lvl2pPr>
            <a:lvl3pPr marL="1821668" indent="0" algn="ctr">
              <a:buNone/>
              <a:defRPr sz="3586"/>
            </a:lvl3pPr>
            <a:lvl4pPr marL="2732502" indent="0" algn="ctr">
              <a:buNone/>
              <a:defRPr sz="3188"/>
            </a:lvl4pPr>
            <a:lvl5pPr marL="3643335" indent="0" algn="ctr">
              <a:buNone/>
              <a:defRPr sz="3188"/>
            </a:lvl5pPr>
            <a:lvl6pPr marL="4554169" indent="0" algn="ctr">
              <a:buNone/>
              <a:defRPr sz="3188"/>
            </a:lvl6pPr>
            <a:lvl7pPr marL="5465003" indent="0" algn="ctr">
              <a:buNone/>
              <a:defRPr sz="3188"/>
            </a:lvl7pPr>
            <a:lvl8pPr marL="6375837" indent="0" algn="ctr">
              <a:buNone/>
              <a:defRPr sz="3188"/>
            </a:lvl8pPr>
            <a:lvl9pPr marL="7286671" indent="0" algn="ctr">
              <a:buNone/>
              <a:defRPr sz="3188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822378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20101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36229" y="730250"/>
            <a:ext cx="3927946" cy="11623676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2390" y="730250"/>
            <a:ext cx="11556132" cy="11623676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063606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515268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2902" y="3419479"/>
            <a:ext cx="15711786" cy="5705474"/>
          </a:xfrm>
        </p:spPr>
        <p:txBody>
          <a:bodyPr anchor="b"/>
          <a:lstStyle>
            <a:lvl1pPr>
              <a:defRPr sz="11953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2902" y="9178929"/>
            <a:ext cx="15711786" cy="3000374"/>
          </a:xfrm>
        </p:spPr>
        <p:txBody>
          <a:bodyPr/>
          <a:lstStyle>
            <a:lvl1pPr marL="0" indent="0">
              <a:buNone/>
              <a:defRPr sz="4781">
                <a:solidFill>
                  <a:schemeClr val="tx1"/>
                </a:solidFill>
              </a:defRPr>
            </a:lvl1pPr>
            <a:lvl2pPr marL="910834" indent="0">
              <a:buNone/>
              <a:defRPr sz="3984">
                <a:solidFill>
                  <a:schemeClr val="tx1">
                    <a:tint val="75000"/>
                  </a:schemeClr>
                </a:solidFill>
              </a:defRPr>
            </a:lvl2pPr>
            <a:lvl3pPr marL="1821668" indent="0">
              <a:buNone/>
              <a:defRPr sz="3586">
                <a:solidFill>
                  <a:schemeClr val="tx1">
                    <a:tint val="75000"/>
                  </a:schemeClr>
                </a:solidFill>
              </a:defRPr>
            </a:lvl3pPr>
            <a:lvl4pPr marL="2732502" indent="0">
              <a:buNone/>
              <a:defRPr sz="3188">
                <a:solidFill>
                  <a:schemeClr val="tx1">
                    <a:tint val="75000"/>
                  </a:schemeClr>
                </a:solidFill>
              </a:defRPr>
            </a:lvl4pPr>
            <a:lvl5pPr marL="3643335" indent="0">
              <a:buNone/>
              <a:defRPr sz="3188">
                <a:solidFill>
                  <a:schemeClr val="tx1">
                    <a:tint val="75000"/>
                  </a:schemeClr>
                </a:solidFill>
              </a:defRPr>
            </a:lvl5pPr>
            <a:lvl6pPr marL="4554169" indent="0">
              <a:buNone/>
              <a:defRPr sz="3188">
                <a:solidFill>
                  <a:schemeClr val="tx1">
                    <a:tint val="75000"/>
                  </a:schemeClr>
                </a:solidFill>
              </a:defRPr>
            </a:lvl6pPr>
            <a:lvl7pPr marL="5465003" indent="0">
              <a:buNone/>
              <a:defRPr sz="3188">
                <a:solidFill>
                  <a:schemeClr val="tx1">
                    <a:tint val="75000"/>
                  </a:schemeClr>
                </a:solidFill>
              </a:defRPr>
            </a:lvl7pPr>
            <a:lvl8pPr marL="6375837" indent="0">
              <a:buNone/>
              <a:defRPr sz="3188">
                <a:solidFill>
                  <a:schemeClr val="tx1">
                    <a:tint val="75000"/>
                  </a:schemeClr>
                </a:solidFill>
              </a:defRPr>
            </a:lvl8pPr>
            <a:lvl9pPr marL="7286671" indent="0">
              <a:buNone/>
              <a:defRPr sz="31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470539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2389" y="3651250"/>
            <a:ext cx="7742039" cy="870267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22135" y="3651250"/>
            <a:ext cx="7742039" cy="870267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111869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761" y="730253"/>
            <a:ext cx="15711786" cy="2651126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4763" y="3362326"/>
            <a:ext cx="7706459" cy="1647824"/>
          </a:xfrm>
        </p:spPr>
        <p:txBody>
          <a:bodyPr anchor="b"/>
          <a:lstStyle>
            <a:lvl1pPr marL="0" indent="0">
              <a:buNone/>
              <a:defRPr sz="4781" b="1"/>
            </a:lvl1pPr>
            <a:lvl2pPr marL="910834" indent="0">
              <a:buNone/>
              <a:defRPr sz="3984" b="1"/>
            </a:lvl2pPr>
            <a:lvl3pPr marL="1821668" indent="0">
              <a:buNone/>
              <a:defRPr sz="3586" b="1"/>
            </a:lvl3pPr>
            <a:lvl4pPr marL="2732502" indent="0">
              <a:buNone/>
              <a:defRPr sz="3188" b="1"/>
            </a:lvl4pPr>
            <a:lvl5pPr marL="3643335" indent="0">
              <a:buNone/>
              <a:defRPr sz="3188" b="1"/>
            </a:lvl5pPr>
            <a:lvl6pPr marL="4554169" indent="0">
              <a:buNone/>
              <a:defRPr sz="3188" b="1"/>
            </a:lvl6pPr>
            <a:lvl7pPr marL="5465003" indent="0">
              <a:buNone/>
              <a:defRPr sz="3188" b="1"/>
            </a:lvl7pPr>
            <a:lvl8pPr marL="6375837" indent="0">
              <a:buNone/>
              <a:defRPr sz="3188" b="1"/>
            </a:lvl8pPr>
            <a:lvl9pPr marL="7286671" indent="0">
              <a:buNone/>
              <a:defRPr sz="3188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4763" y="5010150"/>
            <a:ext cx="7706459" cy="736917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22136" y="3362326"/>
            <a:ext cx="7744412" cy="1647824"/>
          </a:xfrm>
        </p:spPr>
        <p:txBody>
          <a:bodyPr anchor="b"/>
          <a:lstStyle>
            <a:lvl1pPr marL="0" indent="0">
              <a:buNone/>
              <a:defRPr sz="4781" b="1"/>
            </a:lvl1pPr>
            <a:lvl2pPr marL="910834" indent="0">
              <a:buNone/>
              <a:defRPr sz="3984" b="1"/>
            </a:lvl2pPr>
            <a:lvl3pPr marL="1821668" indent="0">
              <a:buNone/>
              <a:defRPr sz="3586" b="1"/>
            </a:lvl3pPr>
            <a:lvl4pPr marL="2732502" indent="0">
              <a:buNone/>
              <a:defRPr sz="3188" b="1"/>
            </a:lvl4pPr>
            <a:lvl5pPr marL="3643335" indent="0">
              <a:buNone/>
              <a:defRPr sz="3188" b="1"/>
            </a:lvl5pPr>
            <a:lvl6pPr marL="4554169" indent="0">
              <a:buNone/>
              <a:defRPr sz="3188" b="1"/>
            </a:lvl6pPr>
            <a:lvl7pPr marL="5465003" indent="0">
              <a:buNone/>
              <a:defRPr sz="3188" b="1"/>
            </a:lvl7pPr>
            <a:lvl8pPr marL="6375837" indent="0">
              <a:buNone/>
              <a:defRPr sz="3188" b="1"/>
            </a:lvl8pPr>
            <a:lvl9pPr marL="7286671" indent="0">
              <a:buNone/>
              <a:defRPr sz="3188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22136" y="5010150"/>
            <a:ext cx="7744412" cy="736917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577338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998262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54881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761" y="914400"/>
            <a:ext cx="5875316" cy="3200400"/>
          </a:xfrm>
        </p:spPr>
        <p:txBody>
          <a:bodyPr anchor="b"/>
          <a:lstStyle>
            <a:lvl1pPr>
              <a:defRPr sz="637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44412" y="1974853"/>
            <a:ext cx="9222135" cy="9747250"/>
          </a:xfrm>
        </p:spPr>
        <p:txBody>
          <a:bodyPr/>
          <a:lstStyle>
            <a:lvl1pPr>
              <a:defRPr sz="6375"/>
            </a:lvl1pPr>
            <a:lvl2pPr>
              <a:defRPr sz="5578"/>
            </a:lvl2pPr>
            <a:lvl3pPr>
              <a:defRPr sz="4781"/>
            </a:lvl3pPr>
            <a:lvl4pPr>
              <a:defRPr sz="3984"/>
            </a:lvl4pPr>
            <a:lvl5pPr>
              <a:defRPr sz="3984"/>
            </a:lvl5pPr>
            <a:lvl6pPr>
              <a:defRPr sz="3984"/>
            </a:lvl6pPr>
            <a:lvl7pPr>
              <a:defRPr sz="3984"/>
            </a:lvl7pPr>
            <a:lvl8pPr>
              <a:defRPr sz="3984"/>
            </a:lvl8pPr>
            <a:lvl9pPr>
              <a:defRPr sz="3984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761" y="4114800"/>
            <a:ext cx="5875316" cy="7623176"/>
          </a:xfrm>
        </p:spPr>
        <p:txBody>
          <a:bodyPr/>
          <a:lstStyle>
            <a:lvl1pPr marL="0" indent="0">
              <a:buNone/>
              <a:defRPr sz="3188"/>
            </a:lvl1pPr>
            <a:lvl2pPr marL="910834" indent="0">
              <a:buNone/>
              <a:defRPr sz="2789"/>
            </a:lvl2pPr>
            <a:lvl3pPr marL="1821668" indent="0">
              <a:buNone/>
              <a:defRPr sz="2391"/>
            </a:lvl3pPr>
            <a:lvl4pPr marL="2732502" indent="0">
              <a:buNone/>
              <a:defRPr sz="1992"/>
            </a:lvl4pPr>
            <a:lvl5pPr marL="3643335" indent="0">
              <a:buNone/>
              <a:defRPr sz="1992"/>
            </a:lvl5pPr>
            <a:lvl6pPr marL="4554169" indent="0">
              <a:buNone/>
              <a:defRPr sz="1992"/>
            </a:lvl6pPr>
            <a:lvl7pPr marL="5465003" indent="0">
              <a:buNone/>
              <a:defRPr sz="1992"/>
            </a:lvl7pPr>
            <a:lvl8pPr marL="6375837" indent="0">
              <a:buNone/>
              <a:defRPr sz="1992"/>
            </a:lvl8pPr>
            <a:lvl9pPr marL="7286671" indent="0">
              <a:buNone/>
              <a:defRPr sz="1992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28321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761" y="914400"/>
            <a:ext cx="5875316" cy="3200400"/>
          </a:xfrm>
        </p:spPr>
        <p:txBody>
          <a:bodyPr anchor="b"/>
          <a:lstStyle>
            <a:lvl1pPr>
              <a:defRPr sz="637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44412" y="1974853"/>
            <a:ext cx="9222135" cy="9747250"/>
          </a:xfrm>
        </p:spPr>
        <p:txBody>
          <a:bodyPr anchor="t"/>
          <a:lstStyle>
            <a:lvl1pPr marL="0" indent="0">
              <a:buNone/>
              <a:defRPr sz="6375"/>
            </a:lvl1pPr>
            <a:lvl2pPr marL="910834" indent="0">
              <a:buNone/>
              <a:defRPr sz="5578"/>
            </a:lvl2pPr>
            <a:lvl3pPr marL="1821668" indent="0">
              <a:buNone/>
              <a:defRPr sz="4781"/>
            </a:lvl3pPr>
            <a:lvl4pPr marL="2732502" indent="0">
              <a:buNone/>
              <a:defRPr sz="3984"/>
            </a:lvl4pPr>
            <a:lvl5pPr marL="3643335" indent="0">
              <a:buNone/>
              <a:defRPr sz="3984"/>
            </a:lvl5pPr>
            <a:lvl6pPr marL="4554169" indent="0">
              <a:buNone/>
              <a:defRPr sz="3984"/>
            </a:lvl6pPr>
            <a:lvl7pPr marL="5465003" indent="0">
              <a:buNone/>
              <a:defRPr sz="3984"/>
            </a:lvl7pPr>
            <a:lvl8pPr marL="6375837" indent="0">
              <a:buNone/>
              <a:defRPr sz="3984"/>
            </a:lvl8pPr>
            <a:lvl9pPr marL="7286671" indent="0">
              <a:buNone/>
              <a:defRPr sz="3984"/>
            </a:lvl9pPr>
          </a:lstStyle>
          <a:p>
            <a:r>
              <a:rPr lang="zh-TW" altLang="en-US"/>
              <a:t>將圖片拖曳至版面配置區或按一下圖示以新增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761" y="4114800"/>
            <a:ext cx="5875316" cy="7623176"/>
          </a:xfrm>
        </p:spPr>
        <p:txBody>
          <a:bodyPr/>
          <a:lstStyle>
            <a:lvl1pPr marL="0" indent="0">
              <a:buNone/>
              <a:defRPr sz="3188"/>
            </a:lvl1pPr>
            <a:lvl2pPr marL="910834" indent="0">
              <a:buNone/>
              <a:defRPr sz="2789"/>
            </a:lvl2pPr>
            <a:lvl3pPr marL="1821668" indent="0">
              <a:buNone/>
              <a:defRPr sz="2391"/>
            </a:lvl3pPr>
            <a:lvl4pPr marL="2732502" indent="0">
              <a:buNone/>
              <a:defRPr sz="1992"/>
            </a:lvl4pPr>
            <a:lvl5pPr marL="3643335" indent="0">
              <a:buNone/>
              <a:defRPr sz="1992"/>
            </a:lvl5pPr>
            <a:lvl6pPr marL="4554169" indent="0">
              <a:buNone/>
              <a:defRPr sz="1992"/>
            </a:lvl6pPr>
            <a:lvl7pPr marL="5465003" indent="0">
              <a:buNone/>
              <a:defRPr sz="1992"/>
            </a:lvl7pPr>
            <a:lvl8pPr marL="6375837" indent="0">
              <a:buNone/>
              <a:defRPr sz="1992"/>
            </a:lvl8pPr>
            <a:lvl9pPr marL="7286671" indent="0">
              <a:buNone/>
              <a:defRPr sz="1992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55901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2389" y="730253"/>
            <a:ext cx="15711786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2389" y="3651250"/>
            <a:ext cx="15711786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2389" y="12712703"/>
            <a:ext cx="4098727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C7B9A-BBE4-F041-9878-BD5A6B39A057}" type="datetimeFigureOut">
              <a:rPr kumimoji="1" lang="zh-TW" altLang="en-US" smtClean="0"/>
              <a:t>2021/3/2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34237" y="12712703"/>
            <a:ext cx="614809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865447" y="12712703"/>
            <a:ext cx="4098727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FE999-D227-C04F-83F8-37A3B8B57FE0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09351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821668" rtl="0" eaLnBrk="1" latinLnBrk="0" hangingPunct="1">
        <a:lnSpc>
          <a:spcPct val="90000"/>
        </a:lnSpc>
        <a:spcBef>
          <a:spcPct val="0"/>
        </a:spcBef>
        <a:buNone/>
        <a:defRPr sz="876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5417" indent="-455417" algn="l" defTabSz="1821668" rtl="0" eaLnBrk="1" latinLnBrk="0" hangingPunct="1">
        <a:lnSpc>
          <a:spcPct val="90000"/>
        </a:lnSpc>
        <a:spcBef>
          <a:spcPts val="1992"/>
        </a:spcBef>
        <a:buFont typeface="Arial" panose="020B0604020202020204" pitchFamily="34" charset="0"/>
        <a:buChar char="•"/>
        <a:defRPr sz="5578" kern="1200">
          <a:solidFill>
            <a:schemeClr val="tx1"/>
          </a:solidFill>
          <a:latin typeface="+mn-lt"/>
          <a:ea typeface="+mn-ea"/>
          <a:cs typeface="+mn-cs"/>
        </a:defRPr>
      </a:lvl1pPr>
      <a:lvl2pPr marL="1366251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4781" kern="1200">
          <a:solidFill>
            <a:schemeClr val="tx1"/>
          </a:solidFill>
          <a:latin typeface="+mn-lt"/>
          <a:ea typeface="+mn-ea"/>
          <a:cs typeface="+mn-cs"/>
        </a:defRPr>
      </a:lvl2pPr>
      <a:lvl3pPr marL="2277085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3984" kern="1200">
          <a:solidFill>
            <a:schemeClr val="tx1"/>
          </a:solidFill>
          <a:latin typeface="+mn-lt"/>
          <a:ea typeface="+mn-ea"/>
          <a:cs typeface="+mn-cs"/>
        </a:defRPr>
      </a:lvl3pPr>
      <a:lvl4pPr marL="3187918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3586" kern="1200">
          <a:solidFill>
            <a:schemeClr val="tx1"/>
          </a:solidFill>
          <a:latin typeface="+mn-lt"/>
          <a:ea typeface="+mn-ea"/>
          <a:cs typeface="+mn-cs"/>
        </a:defRPr>
      </a:lvl4pPr>
      <a:lvl5pPr marL="4098752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3586" kern="1200">
          <a:solidFill>
            <a:schemeClr val="tx1"/>
          </a:solidFill>
          <a:latin typeface="+mn-lt"/>
          <a:ea typeface="+mn-ea"/>
          <a:cs typeface="+mn-cs"/>
        </a:defRPr>
      </a:lvl5pPr>
      <a:lvl6pPr marL="5009586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3586" kern="1200">
          <a:solidFill>
            <a:schemeClr val="tx1"/>
          </a:solidFill>
          <a:latin typeface="+mn-lt"/>
          <a:ea typeface="+mn-ea"/>
          <a:cs typeface="+mn-cs"/>
        </a:defRPr>
      </a:lvl6pPr>
      <a:lvl7pPr marL="5920420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3586" kern="1200">
          <a:solidFill>
            <a:schemeClr val="tx1"/>
          </a:solidFill>
          <a:latin typeface="+mn-lt"/>
          <a:ea typeface="+mn-ea"/>
          <a:cs typeface="+mn-cs"/>
        </a:defRPr>
      </a:lvl7pPr>
      <a:lvl8pPr marL="6831254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3586" kern="1200">
          <a:solidFill>
            <a:schemeClr val="tx1"/>
          </a:solidFill>
          <a:latin typeface="+mn-lt"/>
          <a:ea typeface="+mn-ea"/>
          <a:cs typeface="+mn-cs"/>
        </a:defRPr>
      </a:lvl8pPr>
      <a:lvl9pPr marL="7742088" indent="-455417" algn="l" defTabSz="1821668" rtl="0" eaLnBrk="1" latinLnBrk="0" hangingPunct="1">
        <a:lnSpc>
          <a:spcPct val="90000"/>
        </a:lnSpc>
        <a:spcBef>
          <a:spcPts val="996"/>
        </a:spcBef>
        <a:buFont typeface="Arial" panose="020B0604020202020204" pitchFamily="34" charset="0"/>
        <a:buChar char="•"/>
        <a:defRPr sz="358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1pPr>
      <a:lvl2pPr marL="910834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2pPr>
      <a:lvl3pPr marL="1821668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3pPr>
      <a:lvl4pPr marL="2732502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4pPr>
      <a:lvl5pPr marL="3643335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5pPr>
      <a:lvl6pPr marL="4554169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6pPr>
      <a:lvl7pPr marL="5465003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7pPr>
      <a:lvl8pPr marL="6375837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8pPr>
      <a:lvl9pPr marL="7286671" algn="l" defTabSz="1821668" rtl="0" eaLnBrk="1" latinLnBrk="0" hangingPunct="1">
        <a:defRPr sz="358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字方塊 47"/>
          <p:cNvSpPr txBox="1"/>
          <p:nvPr/>
        </p:nvSpPr>
        <p:spPr>
          <a:xfrm>
            <a:off x="0" y="-483134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2000" dirty="0">
                <a:latin typeface="Arial" charset="0"/>
                <a:ea typeface="Arial" charset="0"/>
                <a:cs typeface="Arial" charset="0"/>
              </a:rPr>
              <a:t>Figure</a:t>
            </a:r>
            <a:r>
              <a:rPr kumimoji="1" lang="zh-TW" altLang="en-US" sz="2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kumimoji="1" lang="en-US" altLang="zh-TW" sz="2000" dirty="0" smtClean="0">
                <a:latin typeface="Arial" charset="0"/>
                <a:ea typeface="Arial" charset="0"/>
                <a:cs typeface="Arial" charset="0"/>
              </a:rPr>
              <a:t>S1</a:t>
            </a:r>
            <a:endParaRPr kumimoji="1" lang="en-US" altLang="zh-TW" sz="2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38" name="群組 137">
            <a:extLst>
              <a:ext uri="{FF2B5EF4-FFF2-40B4-BE49-F238E27FC236}">
                <a16:creationId xmlns:a16="http://schemas.microsoft.com/office/drawing/2014/main" xmlns="" id="{BBD1718D-27ED-3A41-89AF-EE49151031AA}"/>
              </a:ext>
            </a:extLst>
          </p:cNvPr>
          <p:cNvGrpSpPr/>
          <p:nvPr/>
        </p:nvGrpSpPr>
        <p:grpSpPr>
          <a:xfrm>
            <a:off x="9397522" y="6672175"/>
            <a:ext cx="8053850" cy="6426272"/>
            <a:chOff x="69913" y="276081"/>
            <a:chExt cx="8053850" cy="6426272"/>
          </a:xfrm>
        </p:grpSpPr>
        <p:sp>
          <p:nvSpPr>
            <p:cNvPr id="139" name="文字方塊 138">
              <a:extLst>
                <a:ext uri="{FF2B5EF4-FFF2-40B4-BE49-F238E27FC236}">
                  <a16:creationId xmlns:a16="http://schemas.microsoft.com/office/drawing/2014/main" xmlns="" id="{010287F9-88CF-C34E-8479-7C0B44AA58C3}"/>
                </a:ext>
              </a:extLst>
            </p:cNvPr>
            <p:cNvSpPr txBox="1"/>
            <p:nvPr/>
          </p:nvSpPr>
          <p:spPr>
            <a:xfrm>
              <a:off x="69913" y="276081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2400" dirty="0">
                  <a:latin typeface="Arial" charset="0"/>
                  <a:ea typeface="Arial" charset="0"/>
                  <a:cs typeface="Arial" charset="0"/>
                </a:rPr>
                <a:t>D</a:t>
              </a:r>
            </a:p>
          </p:txBody>
        </p:sp>
        <p:grpSp>
          <p:nvGrpSpPr>
            <p:cNvPr id="140" name="群組 139">
              <a:extLst>
                <a:ext uri="{FF2B5EF4-FFF2-40B4-BE49-F238E27FC236}">
                  <a16:creationId xmlns:a16="http://schemas.microsoft.com/office/drawing/2014/main" xmlns="" id="{DC43FD31-4834-5E49-B55A-A957A01EACD5}"/>
                </a:ext>
              </a:extLst>
            </p:cNvPr>
            <p:cNvGrpSpPr/>
            <p:nvPr/>
          </p:nvGrpSpPr>
          <p:grpSpPr>
            <a:xfrm>
              <a:off x="83574" y="897685"/>
              <a:ext cx="7956892" cy="5804668"/>
              <a:chOff x="83574" y="897685"/>
              <a:chExt cx="7956892" cy="5804668"/>
            </a:xfrm>
          </p:grpSpPr>
          <p:pic>
            <p:nvPicPr>
              <p:cNvPr id="159" name="圖片 158">
                <a:extLst>
                  <a:ext uri="{FF2B5EF4-FFF2-40B4-BE49-F238E27FC236}">
                    <a16:creationId xmlns:a16="http://schemas.microsoft.com/office/drawing/2014/main" xmlns="" id="{E178A769-7AD0-5541-8D10-6CFE4D968D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776" t="7170" r="25840" b="10994"/>
              <a:stretch/>
            </p:blipFill>
            <p:spPr>
              <a:xfrm>
                <a:off x="341716" y="897685"/>
                <a:ext cx="7698750" cy="5435600"/>
              </a:xfrm>
              <a:prstGeom prst="rect">
                <a:avLst/>
              </a:prstGeom>
            </p:spPr>
          </p:pic>
          <p:sp>
            <p:nvSpPr>
              <p:cNvPr id="160" name="文字方塊 159">
                <a:extLst>
                  <a:ext uri="{FF2B5EF4-FFF2-40B4-BE49-F238E27FC236}">
                    <a16:creationId xmlns:a16="http://schemas.microsoft.com/office/drawing/2014/main" xmlns="" id="{E03F1840-59CE-E349-A1EF-DD0E83E78F58}"/>
                  </a:ext>
                </a:extLst>
              </p:cNvPr>
              <p:cNvSpPr txBox="1"/>
              <p:nvPr/>
            </p:nvSpPr>
            <p:spPr>
              <a:xfrm rot="10800000">
                <a:off x="83574" y="1471270"/>
                <a:ext cx="492443" cy="42884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txBody>
              <a:bodyPr rot="0" spcFirstLastPara="0" vert="eaVert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altLang="zh-TW" sz="2000" kern="100" dirty="0">
                    <a:latin typeface="Arial" charset="0"/>
                    <a:ea typeface="Arial" charset="0"/>
                    <a:cs typeface="Arial" charset="0"/>
                  </a:rPr>
                  <a:t>O</a:t>
                </a:r>
                <a:r>
                  <a:rPr lang="en-US" sz="2000" kern="100" dirty="0">
                    <a:latin typeface="Arial" charset="0"/>
                    <a:ea typeface="Arial" charset="0"/>
                    <a:cs typeface="Arial" charset="0"/>
                  </a:rPr>
                  <a:t>verall survival (%)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1" name="文字方塊 160">
                <a:extLst>
                  <a:ext uri="{FF2B5EF4-FFF2-40B4-BE49-F238E27FC236}">
                    <a16:creationId xmlns:a16="http://schemas.microsoft.com/office/drawing/2014/main" xmlns="" id="{3F881508-6D00-8048-9AEC-87B445BDF0C5}"/>
                  </a:ext>
                </a:extLst>
              </p:cNvPr>
              <p:cNvSpPr txBox="1"/>
              <p:nvPr/>
            </p:nvSpPr>
            <p:spPr>
              <a:xfrm>
                <a:off x="2615662" y="6286620"/>
                <a:ext cx="3907930" cy="41573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Follow up time (months) </a:t>
                </a:r>
                <a:r>
                  <a:rPr lang="zh-TW" alt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41" name="群組 140">
              <a:extLst>
                <a:ext uri="{FF2B5EF4-FFF2-40B4-BE49-F238E27FC236}">
                  <a16:creationId xmlns:a16="http://schemas.microsoft.com/office/drawing/2014/main" xmlns="" id="{D32A555F-3187-2A42-AF40-DA39AEA6D2B1}"/>
                </a:ext>
              </a:extLst>
            </p:cNvPr>
            <p:cNvGrpSpPr/>
            <p:nvPr/>
          </p:nvGrpSpPr>
          <p:grpSpPr>
            <a:xfrm>
              <a:off x="3635896" y="864546"/>
              <a:ext cx="4487867" cy="2259840"/>
              <a:chOff x="4533900" y="557248"/>
              <a:chExt cx="4487867" cy="2259840"/>
            </a:xfrm>
          </p:grpSpPr>
          <p:grpSp>
            <p:nvGrpSpPr>
              <p:cNvPr id="142" name="群組 141">
                <a:extLst>
                  <a:ext uri="{FF2B5EF4-FFF2-40B4-BE49-F238E27FC236}">
                    <a16:creationId xmlns:a16="http://schemas.microsoft.com/office/drawing/2014/main" xmlns="" id="{52854841-EFC1-3F4C-A48C-4CD19FAEA5A4}"/>
                  </a:ext>
                </a:extLst>
              </p:cNvPr>
              <p:cNvGrpSpPr/>
              <p:nvPr/>
            </p:nvGrpSpPr>
            <p:grpSpPr>
              <a:xfrm>
                <a:off x="4533900" y="796151"/>
                <a:ext cx="1241121" cy="2020937"/>
                <a:chOff x="4533900" y="796151"/>
                <a:chExt cx="1241121" cy="2020937"/>
              </a:xfrm>
            </p:grpSpPr>
            <p:pic>
              <p:nvPicPr>
                <p:cNvPr id="157" name="圖片 156">
                  <a:extLst>
                    <a:ext uri="{FF2B5EF4-FFF2-40B4-BE49-F238E27FC236}">
                      <a16:creationId xmlns:a16="http://schemas.microsoft.com/office/drawing/2014/main" xmlns="" id="{6C20FEC8-9ADC-E042-A9D4-6F2CD64E0F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75424" t="11080" r="21056" b="70947"/>
                <a:stretch/>
              </p:blipFill>
              <p:spPr>
                <a:xfrm>
                  <a:off x="4533900" y="863599"/>
                  <a:ext cx="457199" cy="1953489"/>
                </a:xfrm>
                <a:prstGeom prst="rect">
                  <a:avLst/>
                </a:prstGeom>
              </p:spPr>
            </p:pic>
            <p:sp>
              <p:nvSpPr>
                <p:cNvPr id="158" name="文字方塊 157">
                  <a:extLst>
                    <a:ext uri="{FF2B5EF4-FFF2-40B4-BE49-F238E27FC236}">
                      <a16:creationId xmlns:a16="http://schemas.microsoft.com/office/drawing/2014/main" xmlns="" id="{B95C9E4C-4E5B-AC49-A1BC-3EDD4BADDBE8}"/>
                    </a:ext>
                  </a:extLst>
                </p:cNvPr>
                <p:cNvSpPr txBox="1"/>
                <p:nvPr/>
              </p:nvSpPr>
              <p:spPr>
                <a:xfrm>
                  <a:off x="4982753" y="796151"/>
                  <a:ext cx="792268" cy="19236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TW" sz="1700" dirty="0">
                      <a:latin typeface="Arial" charset="0"/>
                      <a:ea typeface="Arial" charset="0"/>
                      <a:cs typeface="Arial" charset="0"/>
                    </a:rPr>
                    <a:t>SR</a:t>
                  </a:r>
                </a:p>
                <a:p>
                  <a:r>
                    <a:rPr kumimoji="1" lang="en-US" altLang="zh-TW" sz="1700" dirty="0">
                      <a:latin typeface="Arial" charset="0"/>
                      <a:ea typeface="Arial" charset="0"/>
                      <a:cs typeface="Arial" charset="0"/>
                    </a:rPr>
                    <a:t>RFA</a:t>
                  </a:r>
                </a:p>
                <a:p>
                  <a:r>
                    <a:rPr kumimoji="1" lang="en-US" altLang="zh-TW" sz="1700" dirty="0">
                      <a:latin typeface="Arial" charset="0"/>
                      <a:ea typeface="Arial" charset="0"/>
                      <a:cs typeface="Arial" charset="0"/>
                    </a:rPr>
                    <a:t>TACE</a:t>
                  </a:r>
                </a:p>
                <a:p>
                  <a:r>
                    <a:rPr kumimoji="1" lang="en-US" altLang="zh-TW" sz="1700" dirty="0">
                      <a:latin typeface="Arial" charset="0"/>
                      <a:ea typeface="Arial" charset="0"/>
                      <a:cs typeface="Arial" charset="0"/>
                    </a:rPr>
                    <a:t>Target</a:t>
                  </a:r>
                </a:p>
                <a:p>
                  <a:r>
                    <a:rPr kumimoji="1" lang="en-US" altLang="zh-TW" sz="1700" dirty="0">
                      <a:latin typeface="Arial" charset="0"/>
                      <a:ea typeface="Arial" charset="0"/>
                      <a:cs typeface="Arial" charset="0"/>
                    </a:rPr>
                    <a:t>RT</a:t>
                  </a:r>
                </a:p>
                <a:p>
                  <a:r>
                    <a:rPr kumimoji="1" lang="en-US" altLang="zh-TW" sz="1700" dirty="0">
                      <a:latin typeface="Arial" charset="0"/>
                      <a:ea typeface="Arial" charset="0"/>
                      <a:cs typeface="Arial" charset="0"/>
                    </a:rPr>
                    <a:t>HAIC</a:t>
                  </a:r>
                </a:p>
                <a:p>
                  <a:r>
                    <a:rPr kumimoji="1" lang="en-US" altLang="zh-TW" sz="1700" dirty="0">
                      <a:latin typeface="Arial" charset="0"/>
                      <a:ea typeface="Arial" charset="0"/>
                      <a:cs typeface="Arial" charset="0"/>
                    </a:rPr>
                    <a:t>BSC</a:t>
                  </a:r>
                  <a:endParaRPr kumimoji="1" lang="zh-TW" altLang="en-US" sz="17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43" name="右中括弧 142">
                <a:extLst>
                  <a:ext uri="{FF2B5EF4-FFF2-40B4-BE49-F238E27FC236}">
                    <a16:creationId xmlns:a16="http://schemas.microsoft.com/office/drawing/2014/main" xmlns="" id="{716C32B7-6283-1D4A-813D-7410298CAAAF}"/>
                  </a:ext>
                </a:extLst>
              </p:cNvPr>
              <p:cNvSpPr/>
              <p:nvPr/>
            </p:nvSpPr>
            <p:spPr>
              <a:xfrm>
                <a:off x="6214588" y="914400"/>
                <a:ext cx="72000" cy="936000"/>
              </a:xfrm>
              <a:prstGeom prst="righ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17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4" name="右中括弧 143">
                <a:extLst>
                  <a:ext uri="{FF2B5EF4-FFF2-40B4-BE49-F238E27FC236}">
                    <a16:creationId xmlns:a16="http://schemas.microsoft.com/office/drawing/2014/main" xmlns="" id="{AF6C95BC-A0D8-674A-B1E1-3893B8C8C7CF}"/>
                  </a:ext>
                </a:extLst>
              </p:cNvPr>
              <p:cNvSpPr/>
              <p:nvPr/>
            </p:nvSpPr>
            <p:spPr>
              <a:xfrm>
                <a:off x="6358234" y="918783"/>
                <a:ext cx="72000" cy="720000"/>
              </a:xfrm>
              <a:prstGeom prst="righ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17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5" name="右中括弧 144">
                <a:extLst>
                  <a:ext uri="{FF2B5EF4-FFF2-40B4-BE49-F238E27FC236}">
                    <a16:creationId xmlns:a16="http://schemas.microsoft.com/office/drawing/2014/main" xmlns="" id="{F944B968-8E4D-EE45-8557-83629E9ABA26}"/>
                  </a:ext>
                </a:extLst>
              </p:cNvPr>
              <p:cNvSpPr/>
              <p:nvPr/>
            </p:nvSpPr>
            <p:spPr>
              <a:xfrm>
                <a:off x="6477719" y="916795"/>
                <a:ext cx="72000" cy="396000"/>
              </a:xfrm>
              <a:prstGeom prst="righ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17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46" name="直線接點 145">
                <a:extLst>
                  <a:ext uri="{FF2B5EF4-FFF2-40B4-BE49-F238E27FC236}">
                    <a16:creationId xmlns:a16="http://schemas.microsoft.com/office/drawing/2014/main" xmlns="" id="{748E2834-D6A9-6847-8E41-18A0BF3EA5BB}"/>
                  </a:ext>
                </a:extLst>
              </p:cNvPr>
              <p:cNvCxnSpPr/>
              <p:nvPr/>
            </p:nvCxnSpPr>
            <p:spPr>
              <a:xfrm>
                <a:off x="6290555" y="1778293"/>
                <a:ext cx="360000" cy="755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直線接點 146">
                <a:extLst>
                  <a:ext uri="{FF2B5EF4-FFF2-40B4-BE49-F238E27FC236}">
                    <a16:creationId xmlns:a16="http://schemas.microsoft.com/office/drawing/2014/main" xmlns="" id="{A74423FB-9FE8-B24B-A1DA-951A5D2F41DC}"/>
                  </a:ext>
                </a:extLst>
              </p:cNvPr>
              <p:cNvCxnSpPr/>
              <p:nvPr/>
            </p:nvCxnSpPr>
            <p:spPr>
              <a:xfrm flipV="1">
                <a:off x="6437349" y="1509530"/>
                <a:ext cx="216000" cy="2145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線接點 147">
                <a:extLst>
                  <a:ext uri="{FF2B5EF4-FFF2-40B4-BE49-F238E27FC236}">
                    <a16:creationId xmlns:a16="http://schemas.microsoft.com/office/drawing/2014/main" xmlns="" id="{DAFE58A7-B63C-CD4A-A1F4-AC42ED455EFE}"/>
                  </a:ext>
                </a:extLst>
              </p:cNvPr>
              <p:cNvCxnSpPr/>
              <p:nvPr/>
            </p:nvCxnSpPr>
            <p:spPr>
              <a:xfrm flipV="1">
                <a:off x="6570093" y="1162317"/>
                <a:ext cx="72000" cy="2145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右中括弧 148">
                <a:extLst>
                  <a:ext uri="{FF2B5EF4-FFF2-40B4-BE49-F238E27FC236}">
                    <a16:creationId xmlns:a16="http://schemas.microsoft.com/office/drawing/2014/main" xmlns="" id="{25D5E489-2AD7-7143-B1A9-A51CCCD71C0E}"/>
                  </a:ext>
                </a:extLst>
              </p:cNvPr>
              <p:cNvSpPr/>
              <p:nvPr/>
            </p:nvSpPr>
            <p:spPr>
              <a:xfrm>
                <a:off x="6052588" y="916470"/>
                <a:ext cx="72000" cy="1188000"/>
              </a:xfrm>
              <a:prstGeom prst="righ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17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0" name="直線接點 149">
                <a:extLst>
                  <a:ext uri="{FF2B5EF4-FFF2-40B4-BE49-F238E27FC236}">
                    <a16:creationId xmlns:a16="http://schemas.microsoft.com/office/drawing/2014/main" xmlns="" id="{45B71B10-58BA-F44A-B752-6280B849C57C}"/>
                  </a:ext>
                </a:extLst>
              </p:cNvPr>
              <p:cNvCxnSpPr/>
              <p:nvPr/>
            </p:nvCxnSpPr>
            <p:spPr>
              <a:xfrm>
                <a:off x="6128555" y="2008963"/>
                <a:ext cx="540000" cy="755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右中括弧 150">
                <a:extLst>
                  <a:ext uri="{FF2B5EF4-FFF2-40B4-BE49-F238E27FC236}">
                    <a16:creationId xmlns:a16="http://schemas.microsoft.com/office/drawing/2014/main" xmlns="" id="{DFC80D17-7841-9E45-9273-7DB83E67CD5B}"/>
                  </a:ext>
                </a:extLst>
              </p:cNvPr>
              <p:cNvSpPr/>
              <p:nvPr/>
            </p:nvSpPr>
            <p:spPr>
              <a:xfrm>
                <a:off x="5924560" y="916470"/>
                <a:ext cx="47816" cy="1440000"/>
              </a:xfrm>
              <a:prstGeom prst="righ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17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2" name="直線接點 151">
                <a:extLst>
                  <a:ext uri="{FF2B5EF4-FFF2-40B4-BE49-F238E27FC236}">
                    <a16:creationId xmlns:a16="http://schemas.microsoft.com/office/drawing/2014/main" xmlns="" id="{D8119A4B-D966-4E4D-8AB7-562CF96B5361}"/>
                  </a:ext>
                </a:extLst>
              </p:cNvPr>
              <p:cNvCxnSpPr/>
              <p:nvPr/>
            </p:nvCxnSpPr>
            <p:spPr>
              <a:xfrm flipV="1">
                <a:off x="5975127" y="2298671"/>
                <a:ext cx="720000" cy="322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右中括弧 152">
                <a:extLst>
                  <a:ext uri="{FF2B5EF4-FFF2-40B4-BE49-F238E27FC236}">
                    <a16:creationId xmlns:a16="http://schemas.microsoft.com/office/drawing/2014/main" xmlns="" id="{A154E8F4-CB20-9C44-A588-2E17B9A96D03}"/>
                  </a:ext>
                </a:extLst>
              </p:cNvPr>
              <p:cNvSpPr/>
              <p:nvPr/>
            </p:nvSpPr>
            <p:spPr>
              <a:xfrm>
                <a:off x="5749457" y="916470"/>
                <a:ext cx="52353" cy="1725130"/>
              </a:xfrm>
              <a:prstGeom prst="righ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 sz="17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4" name="直線接點 153">
                <a:extLst>
                  <a:ext uri="{FF2B5EF4-FFF2-40B4-BE49-F238E27FC236}">
                    <a16:creationId xmlns:a16="http://schemas.microsoft.com/office/drawing/2014/main" xmlns="" id="{DBA87A78-15E0-E848-8B0A-3736D063A907}"/>
                  </a:ext>
                </a:extLst>
              </p:cNvPr>
              <p:cNvCxnSpPr/>
              <p:nvPr/>
            </p:nvCxnSpPr>
            <p:spPr>
              <a:xfrm>
                <a:off x="5801810" y="2545371"/>
                <a:ext cx="864000" cy="1292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文字方塊 154">
                <a:extLst>
                  <a:ext uri="{FF2B5EF4-FFF2-40B4-BE49-F238E27FC236}">
                    <a16:creationId xmlns:a16="http://schemas.microsoft.com/office/drawing/2014/main" xmlns="" id="{3491695E-3F2F-4841-AA74-780358C9CA5B}"/>
                  </a:ext>
                </a:extLst>
              </p:cNvPr>
              <p:cNvSpPr txBox="1"/>
              <p:nvPr/>
            </p:nvSpPr>
            <p:spPr>
              <a:xfrm>
                <a:off x="6214588" y="557248"/>
                <a:ext cx="2807179" cy="3539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        HR (95%CI),   p-value</a:t>
                </a:r>
                <a:endParaRPr kumimoji="1" lang="zh-TW" altLang="en-US" sz="17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6" name="文字方塊 155">
                <a:extLst>
                  <a:ext uri="{FF2B5EF4-FFF2-40B4-BE49-F238E27FC236}">
                    <a16:creationId xmlns:a16="http://schemas.microsoft.com/office/drawing/2014/main" xmlns="" id="{471255D4-ED1E-B646-9C77-791A2870C34B}"/>
                  </a:ext>
                </a:extLst>
              </p:cNvPr>
              <p:cNvSpPr txBox="1"/>
              <p:nvPr/>
            </p:nvSpPr>
            <p:spPr>
              <a:xfrm>
                <a:off x="6640956" y="729214"/>
                <a:ext cx="2050561" cy="19236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kumimoji="1" lang="en-US" altLang="zh-TW" sz="1700" dirty="0">
                  <a:latin typeface="Arial" charset="0"/>
                  <a:ea typeface="Arial" charset="0"/>
                  <a:cs typeface="Arial" charset="0"/>
                </a:endParaRPr>
              </a:p>
              <a:p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2.1 (1.1-3.5),</a:t>
                </a:r>
                <a:r>
                  <a:rPr kumimoji="1" lang="zh-TW" altLang="en-US" sz="17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0.04</a:t>
                </a:r>
              </a:p>
              <a:p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2.3 (1.5-3.5),</a:t>
                </a:r>
                <a:r>
                  <a:rPr kumimoji="1" lang="zh-TW" altLang="en-US" sz="17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&lt;.001</a:t>
                </a:r>
              </a:p>
              <a:p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1.9 (1.2-2.9),</a:t>
                </a:r>
                <a:r>
                  <a:rPr kumimoji="1" lang="zh-TW" altLang="en-US" sz="17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0.005</a:t>
                </a:r>
              </a:p>
              <a:p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2.3 (1.4-3.8),</a:t>
                </a:r>
                <a:r>
                  <a:rPr kumimoji="1" lang="zh-TW" altLang="en-US" sz="17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0.002</a:t>
                </a:r>
              </a:p>
              <a:p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1.9 (1.1-3.4),</a:t>
                </a:r>
                <a:r>
                  <a:rPr kumimoji="1" lang="zh-TW" altLang="en-US" sz="17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0.024</a:t>
                </a:r>
              </a:p>
              <a:p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3.3 (2.2-4.9),</a:t>
                </a:r>
                <a:r>
                  <a:rPr kumimoji="1" lang="zh-TW" altLang="en-US" sz="17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700" dirty="0">
                    <a:latin typeface="Arial" charset="0"/>
                    <a:ea typeface="Arial" charset="0"/>
                    <a:cs typeface="Arial" charset="0"/>
                  </a:rPr>
                  <a:t>&lt;.001</a:t>
                </a:r>
                <a:endParaRPr kumimoji="1" lang="zh-TW" altLang="en-US" sz="17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162" name="群組 161"/>
          <p:cNvGrpSpPr/>
          <p:nvPr/>
        </p:nvGrpSpPr>
        <p:grpSpPr>
          <a:xfrm>
            <a:off x="813768" y="247468"/>
            <a:ext cx="7822775" cy="6473710"/>
            <a:chOff x="410410" y="22330"/>
            <a:chExt cx="7822775" cy="6473710"/>
          </a:xfrm>
        </p:grpSpPr>
        <p:sp>
          <p:nvSpPr>
            <p:cNvPr id="163" name="文字方塊 162"/>
            <p:cNvSpPr txBox="1"/>
            <p:nvPr/>
          </p:nvSpPr>
          <p:spPr>
            <a:xfrm>
              <a:off x="410410" y="22330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2400" dirty="0" smtClean="0">
                  <a:latin typeface="Arial" charset="0"/>
                  <a:ea typeface="Arial" charset="0"/>
                  <a:cs typeface="Arial" charset="0"/>
                </a:rPr>
                <a:t>A</a:t>
              </a:r>
              <a:endParaRPr kumimoji="1" lang="en-US" altLang="zh-TW" sz="24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64" name="群組 163"/>
            <p:cNvGrpSpPr/>
            <p:nvPr/>
          </p:nvGrpSpPr>
          <p:grpSpPr>
            <a:xfrm>
              <a:off x="475128" y="661009"/>
              <a:ext cx="7224508" cy="5835031"/>
              <a:chOff x="475128" y="661009"/>
              <a:chExt cx="7224508" cy="5835031"/>
            </a:xfrm>
          </p:grpSpPr>
          <p:pic>
            <p:nvPicPr>
              <p:cNvPr id="184" name="圖片 183"/>
              <p:cNvPicPr>
                <a:picLocks noChangeAspect="1"/>
              </p:cNvPicPr>
              <p:nvPr/>
            </p:nvPicPr>
            <p:blipFill rotWithShape="1">
              <a:blip r:embed="rId3"/>
              <a:srcRect l="5320" t="7936" r="31080" b="7914"/>
              <a:stretch/>
            </p:blipFill>
            <p:spPr>
              <a:xfrm>
                <a:off x="648575" y="661009"/>
                <a:ext cx="7051061" cy="5386237"/>
              </a:xfrm>
              <a:prstGeom prst="rect">
                <a:avLst/>
              </a:prstGeom>
            </p:spPr>
          </p:pic>
          <p:sp>
            <p:nvSpPr>
              <p:cNvPr id="185" name="文字方塊 184"/>
              <p:cNvSpPr txBox="1"/>
              <p:nvPr/>
            </p:nvSpPr>
            <p:spPr>
              <a:xfrm rot="10800000">
                <a:off x="475128" y="1381688"/>
                <a:ext cx="492443" cy="42884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txBody>
              <a:bodyPr rot="0" spcFirstLastPara="0" vert="eaVert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altLang="zh-TW" sz="2000" kern="100" dirty="0">
                    <a:latin typeface="Arial" charset="0"/>
                    <a:ea typeface="Arial" charset="0"/>
                    <a:cs typeface="Arial" charset="0"/>
                  </a:rPr>
                  <a:t>O</a:t>
                </a:r>
                <a:r>
                  <a:rPr lang="en-US" sz="2000" kern="100" dirty="0">
                    <a:latin typeface="Arial" charset="0"/>
                    <a:ea typeface="Arial" charset="0"/>
                    <a:cs typeface="Arial" charset="0"/>
                  </a:rPr>
                  <a:t>verall survival (%)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6" name="文字方塊 185"/>
              <p:cNvSpPr txBox="1"/>
              <p:nvPr/>
            </p:nvSpPr>
            <p:spPr>
              <a:xfrm>
                <a:off x="2329472" y="6080307"/>
                <a:ext cx="3907930" cy="41573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Follow up time (months) </a:t>
                </a:r>
                <a:r>
                  <a:rPr lang="zh-TW" alt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65" name="群組 164"/>
            <p:cNvGrpSpPr/>
            <p:nvPr/>
          </p:nvGrpSpPr>
          <p:grpSpPr>
            <a:xfrm>
              <a:off x="4716016" y="821856"/>
              <a:ext cx="3517169" cy="1275098"/>
              <a:chOff x="1981713" y="4357505"/>
              <a:chExt cx="3438085" cy="1275098"/>
            </a:xfrm>
          </p:grpSpPr>
          <p:grpSp>
            <p:nvGrpSpPr>
              <p:cNvPr id="166" name="群組 165"/>
              <p:cNvGrpSpPr/>
              <p:nvPr/>
            </p:nvGrpSpPr>
            <p:grpSpPr>
              <a:xfrm>
                <a:off x="1981713" y="4555385"/>
                <a:ext cx="1349718" cy="1077218"/>
                <a:chOff x="1981713" y="4555385"/>
                <a:chExt cx="1349718" cy="1077218"/>
              </a:xfrm>
            </p:grpSpPr>
            <p:sp>
              <p:nvSpPr>
                <p:cNvPr id="171" name="文字方塊 170"/>
                <p:cNvSpPr txBox="1"/>
                <p:nvPr/>
              </p:nvSpPr>
              <p:spPr>
                <a:xfrm>
                  <a:off x="2457552" y="4555385"/>
                  <a:ext cx="698425" cy="107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TW" sz="1600" dirty="0">
                      <a:latin typeface="Arial" charset="0"/>
                      <a:ea typeface="Arial" charset="0"/>
                      <a:cs typeface="Arial" charset="0"/>
                    </a:rPr>
                    <a:t>SR</a:t>
                  </a:r>
                </a:p>
                <a:p>
                  <a:r>
                    <a:rPr kumimoji="1" lang="en-US" altLang="zh-TW" sz="1600" dirty="0">
                      <a:latin typeface="Arial" charset="0"/>
                      <a:ea typeface="Arial" charset="0"/>
                      <a:cs typeface="Arial" charset="0"/>
                    </a:rPr>
                    <a:t>RFA</a:t>
                  </a:r>
                </a:p>
                <a:p>
                  <a:r>
                    <a:rPr kumimoji="1" lang="en-US" altLang="zh-TW" sz="1600" dirty="0">
                      <a:latin typeface="Arial" charset="0"/>
                      <a:ea typeface="Arial" charset="0"/>
                      <a:cs typeface="Arial" charset="0"/>
                    </a:rPr>
                    <a:t>TACE</a:t>
                  </a:r>
                </a:p>
                <a:p>
                  <a:endParaRPr kumimoji="1" lang="zh-TW" altLang="en-US" sz="16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72" name="群組 171"/>
                <p:cNvGrpSpPr/>
                <p:nvPr/>
              </p:nvGrpSpPr>
              <p:grpSpPr>
                <a:xfrm>
                  <a:off x="1981713" y="4738854"/>
                  <a:ext cx="488539" cy="558121"/>
                  <a:chOff x="5408748" y="961998"/>
                  <a:chExt cx="488539" cy="558121"/>
                </a:xfrm>
              </p:grpSpPr>
              <p:cxnSp>
                <p:nvCxnSpPr>
                  <p:cNvPr id="178" name="直線接點 177"/>
                  <p:cNvCxnSpPr/>
                  <p:nvPr/>
                </p:nvCxnSpPr>
                <p:spPr>
                  <a:xfrm>
                    <a:off x="5418348" y="961998"/>
                    <a:ext cx="471055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9" name="直線接點 178"/>
                  <p:cNvCxnSpPr/>
                  <p:nvPr/>
                </p:nvCxnSpPr>
                <p:spPr>
                  <a:xfrm>
                    <a:off x="5426232" y="1520119"/>
                    <a:ext cx="471055" cy="0"/>
                  </a:xfrm>
                  <a:prstGeom prst="line">
                    <a:avLst/>
                  </a:prstGeom>
                  <a:ln w="28575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80" name="群組 179"/>
                  <p:cNvGrpSpPr/>
                  <p:nvPr/>
                </p:nvGrpSpPr>
                <p:grpSpPr>
                  <a:xfrm>
                    <a:off x="5408748" y="1243652"/>
                    <a:ext cx="480655" cy="0"/>
                    <a:chOff x="4773232" y="1584240"/>
                    <a:chExt cx="480655" cy="0"/>
                  </a:xfrm>
                </p:grpSpPr>
                <p:cxnSp>
                  <p:nvCxnSpPr>
                    <p:cNvPr id="181" name="直線接點 180"/>
                    <p:cNvCxnSpPr/>
                    <p:nvPr/>
                  </p:nvCxnSpPr>
                  <p:spPr>
                    <a:xfrm>
                      <a:off x="4773232" y="1584240"/>
                      <a:ext cx="14400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2" name="直線接點 181"/>
                    <p:cNvCxnSpPr/>
                    <p:nvPr/>
                  </p:nvCxnSpPr>
                  <p:spPr>
                    <a:xfrm>
                      <a:off x="4944644" y="1584240"/>
                      <a:ext cx="14400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3" name="直線接點 182"/>
                    <p:cNvCxnSpPr/>
                    <p:nvPr/>
                  </p:nvCxnSpPr>
                  <p:spPr>
                    <a:xfrm>
                      <a:off x="5109887" y="1584240"/>
                      <a:ext cx="14400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73" name="群組 172"/>
                <p:cNvGrpSpPr/>
                <p:nvPr/>
              </p:nvGrpSpPr>
              <p:grpSpPr>
                <a:xfrm>
                  <a:off x="3033035" y="4741374"/>
                  <a:ext cx="298396" cy="598239"/>
                  <a:chOff x="6356935" y="1097980"/>
                  <a:chExt cx="298396" cy="723579"/>
                </a:xfrm>
              </p:grpSpPr>
              <p:sp>
                <p:nvSpPr>
                  <p:cNvPr id="174" name="右中括弧 173"/>
                  <p:cNvSpPr/>
                  <p:nvPr/>
                </p:nvSpPr>
                <p:spPr>
                  <a:xfrm>
                    <a:off x="6356935" y="1101559"/>
                    <a:ext cx="72000" cy="720000"/>
                  </a:xfrm>
                  <a:prstGeom prst="rightBracket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zh-TW" altLang="en-US" sz="1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75" name="右中括弧 174"/>
                  <p:cNvSpPr/>
                  <p:nvPr/>
                </p:nvSpPr>
                <p:spPr>
                  <a:xfrm>
                    <a:off x="6515335" y="1097980"/>
                    <a:ext cx="72000" cy="360000"/>
                  </a:xfrm>
                  <a:prstGeom prst="rightBracket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zh-TW" altLang="en-US" sz="1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176" name="直線接點 175"/>
                  <p:cNvCxnSpPr/>
                  <p:nvPr/>
                </p:nvCxnSpPr>
                <p:spPr>
                  <a:xfrm flipV="1">
                    <a:off x="6439331" y="1705999"/>
                    <a:ext cx="216000" cy="2144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7" name="直線接點 176"/>
                  <p:cNvCxnSpPr/>
                  <p:nvPr/>
                </p:nvCxnSpPr>
                <p:spPr>
                  <a:xfrm flipV="1">
                    <a:off x="6582028" y="1406349"/>
                    <a:ext cx="72000" cy="2145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67" name="文字方塊 166"/>
              <p:cNvSpPr txBox="1"/>
              <p:nvPr/>
            </p:nvSpPr>
            <p:spPr>
              <a:xfrm>
                <a:off x="2091264" y="4357505"/>
                <a:ext cx="332853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                      HR (95%CI),  p-value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8" name="文字方塊 167"/>
              <p:cNvSpPr txBox="1"/>
              <p:nvPr/>
            </p:nvSpPr>
            <p:spPr>
              <a:xfrm>
                <a:off x="3297764" y="4555385"/>
                <a:ext cx="23692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9" name="文字方塊 168"/>
              <p:cNvSpPr txBox="1"/>
              <p:nvPr/>
            </p:nvSpPr>
            <p:spPr>
              <a:xfrm>
                <a:off x="3295474" y="4798629"/>
                <a:ext cx="18900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2.1 (1.1-4.4),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0.037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0" name="文字方塊 169"/>
              <p:cNvSpPr txBox="1"/>
              <p:nvPr/>
            </p:nvSpPr>
            <p:spPr>
              <a:xfrm>
                <a:off x="3295474" y="5063198"/>
                <a:ext cx="18900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4.3 (1.3-13),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 </a:t>
                </a:r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0.015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187" name="群組 186">
            <a:extLst>
              <a:ext uri="{FF2B5EF4-FFF2-40B4-BE49-F238E27FC236}">
                <a16:creationId xmlns="" xmlns:a16="http://schemas.microsoft.com/office/drawing/2014/main" id="{6E37532C-E848-FE43-B4B3-5B7D057C8C44}"/>
              </a:ext>
            </a:extLst>
          </p:cNvPr>
          <p:cNvGrpSpPr/>
          <p:nvPr/>
        </p:nvGrpSpPr>
        <p:grpSpPr>
          <a:xfrm>
            <a:off x="9220336" y="110855"/>
            <a:ext cx="7900786" cy="6547028"/>
            <a:chOff x="247605" y="-21787"/>
            <a:chExt cx="7791495" cy="6547028"/>
          </a:xfrm>
        </p:grpSpPr>
        <p:sp>
          <p:nvSpPr>
            <p:cNvPr id="188" name="文字方塊 187">
              <a:extLst>
                <a:ext uri="{FF2B5EF4-FFF2-40B4-BE49-F238E27FC236}">
                  <a16:creationId xmlns="" xmlns:a16="http://schemas.microsoft.com/office/drawing/2014/main" id="{D39D7889-3A52-5645-BE6E-90317420FF98}"/>
                </a:ext>
              </a:extLst>
            </p:cNvPr>
            <p:cNvSpPr txBox="1"/>
            <p:nvPr/>
          </p:nvSpPr>
          <p:spPr>
            <a:xfrm>
              <a:off x="247605" y="-21787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2400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  <p:grpSp>
          <p:nvGrpSpPr>
            <p:cNvPr id="189" name="群組 188">
              <a:extLst>
                <a:ext uri="{FF2B5EF4-FFF2-40B4-BE49-F238E27FC236}">
                  <a16:creationId xmlns="" xmlns:a16="http://schemas.microsoft.com/office/drawing/2014/main" id="{E8984548-666A-734E-9632-DE8375F2FCB7}"/>
                </a:ext>
              </a:extLst>
            </p:cNvPr>
            <p:cNvGrpSpPr/>
            <p:nvPr/>
          </p:nvGrpSpPr>
          <p:grpSpPr>
            <a:xfrm>
              <a:off x="306711" y="754028"/>
              <a:ext cx="7732389" cy="5771213"/>
              <a:chOff x="306711" y="754028"/>
              <a:chExt cx="7732389" cy="5771213"/>
            </a:xfrm>
          </p:grpSpPr>
          <p:pic>
            <p:nvPicPr>
              <p:cNvPr id="208" name="圖片 207">
                <a:extLst>
                  <a:ext uri="{FF2B5EF4-FFF2-40B4-BE49-F238E27FC236}">
                    <a16:creationId xmlns="" xmlns:a16="http://schemas.microsoft.com/office/drawing/2014/main" id="{B5A3DD5A-12EF-2740-991C-101A26DFF7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644" t="7361" r="25860" b="10026"/>
              <a:stretch/>
            </p:blipFill>
            <p:spPr>
              <a:xfrm>
                <a:off x="613411" y="754028"/>
                <a:ext cx="7425689" cy="5487199"/>
              </a:xfrm>
              <a:prstGeom prst="rect">
                <a:avLst/>
              </a:prstGeom>
            </p:spPr>
          </p:pic>
          <p:sp>
            <p:nvSpPr>
              <p:cNvPr id="209" name="文字方塊 208">
                <a:extLst>
                  <a:ext uri="{FF2B5EF4-FFF2-40B4-BE49-F238E27FC236}">
                    <a16:creationId xmlns="" xmlns:a16="http://schemas.microsoft.com/office/drawing/2014/main" id="{D34A399A-EDB3-1443-9F87-17FFCC868997}"/>
                  </a:ext>
                </a:extLst>
              </p:cNvPr>
              <p:cNvSpPr txBox="1"/>
              <p:nvPr/>
            </p:nvSpPr>
            <p:spPr>
              <a:xfrm rot="10800000">
                <a:off x="306711" y="1246465"/>
                <a:ext cx="492443" cy="42884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txBody>
              <a:bodyPr rot="0" spcFirstLastPara="0" vert="eaVert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altLang="zh-TW" sz="2000" kern="100" dirty="0">
                    <a:latin typeface="Arial" charset="0"/>
                    <a:ea typeface="Arial" charset="0"/>
                    <a:cs typeface="Arial" charset="0"/>
                  </a:rPr>
                  <a:t>O</a:t>
                </a:r>
                <a:r>
                  <a:rPr lang="en-US" sz="2000" kern="100" dirty="0">
                    <a:latin typeface="Arial" charset="0"/>
                    <a:ea typeface="Arial" charset="0"/>
                    <a:cs typeface="Arial" charset="0"/>
                  </a:rPr>
                  <a:t>verall survival (%)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0" name="文字方塊 209">
                <a:extLst>
                  <a:ext uri="{FF2B5EF4-FFF2-40B4-BE49-F238E27FC236}">
                    <a16:creationId xmlns="" xmlns:a16="http://schemas.microsoft.com/office/drawing/2014/main" id="{A4627139-EA4E-5449-A9A7-82594B7A2AC8}"/>
                  </a:ext>
                </a:extLst>
              </p:cNvPr>
              <p:cNvSpPr txBox="1"/>
              <p:nvPr/>
            </p:nvSpPr>
            <p:spPr>
              <a:xfrm>
                <a:off x="2368630" y="6109508"/>
                <a:ext cx="3907930" cy="41573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Follow up time (months) </a:t>
                </a:r>
                <a:r>
                  <a:rPr lang="zh-TW" alt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90" name="文字方塊 189">
              <a:extLst>
                <a:ext uri="{FF2B5EF4-FFF2-40B4-BE49-F238E27FC236}">
                  <a16:creationId xmlns="" xmlns:a16="http://schemas.microsoft.com/office/drawing/2014/main" id="{F964B147-AD13-E242-AECE-D0EA893B7D3C}"/>
                </a:ext>
              </a:extLst>
            </p:cNvPr>
            <p:cNvSpPr txBox="1"/>
            <p:nvPr/>
          </p:nvSpPr>
          <p:spPr>
            <a:xfrm>
              <a:off x="7609062" y="1048197"/>
              <a:ext cx="2375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zh-TW" altLang="en-US" dirty="0"/>
                <a:t> </a:t>
              </a:r>
            </a:p>
          </p:txBody>
        </p:sp>
        <p:grpSp>
          <p:nvGrpSpPr>
            <p:cNvPr id="191" name="群組 190">
              <a:extLst>
                <a:ext uri="{FF2B5EF4-FFF2-40B4-BE49-F238E27FC236}">
                  <a16:creationId xmlns="" xmlns:a16="http://schemas.microsoft.com/office/drawing/2014/main" id="{46F44703-36CF-B941-B2A8-73E2B4A1AEFC}"/>
                </a:ext>
              </a:extLst>
            </p:cNvPr>
            <p:cNvGrpSpPr/>
            <p:nvPr/>
          </p:nvGrpSpPr>
          <p:grpSpPr>
            <a:xfrm>
              <a:off x="4301989" y="1207165"/>
              <a:ext cx="3400304" cy="1089728"/>
              <a:chOff x="1380920" y="4577405"/>
              <a:chExt cx="3400304" cy="1089728"/>
            </a:xfrm>
          </p:grpSpPr>
          <p:grpSp>
            <p:nvGrpSpPr>
              <p:cNvPr id="192" name="群組 191">
                <a:extLst>
                  <a:ext uri="{FF2B5EF4-FFF2-40B4-BE49-F238E27FC236}">
                    <a16:creationId xmlns="" xmlns:a16="http://schemas.microsoft.com/office/drawing/2014/main" id="{0782DAD3-D6AA-8F4D-AF02-C629631F1F4D}"/>
                  </a:ext>
                </a:extLst>
              </p:cNvPr>
              <p:cNvGrpSpPr/>
              <p:nvPr/>
            </p:nvGrpSpPr>
            <p:grpSpPr>
              <a:xfrm>
                <a:off x="1380920" y="4759171"/>
                <a:ext cx="1109418" cy="830997"/>
                <a:chOff x="1771606" y="4472294"/>
                <a:chExt cx="1109418" cy="830997"/>
              </a:xfrm>
            </p:grpSpPr>
            <p:cxnSp>
              <p:nvCxnSpPr>
                <p:cNvPr id="202" name="直線接點 201">
                  <a:extLst>
                    <a:ext uri="{FF2B5EF4-FFF2-40B4-BE49-F238E27FC236}">
                      <a16:creationId xmlns="" xmlns:a16="http://schemas.microsoft.com/office/drawing/2014/main" id="{2D7B2F4F-6B47-7344-A443-587665F39E10}"/>
                    </a:ext>
                  </a:extLst>
                </p:cNvPr>
                <p:cNvCxnSpPr/>
                <p:nvPr/>
              </p:nvCxnSpPr>
              <p:spPr>
                <a:xfrm>
                  <a:off x="1781206" y="4641126"/>
                  <a:ext cx="471055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3" name="直線接點 202">
                  <a:extLst>
                    <a:ext uri="{FF2B5EF4-FFF2-40B4-BE49-F238E27FC236}">
                      <a16:creationId xmlns="" xmlns:a16="http://schemas.microsoft.com/office/drawing/2014/main" id="{3A0AF5D9-E7A0-9D44-888C-DF44870E1A6C}"/>
                    </a:ext>
                  </a:extLst>
                </p:cNvPr>
                <p:cNvCxnSpPr/>
                <p:nvPr/>
              </p:nvCxnSpPr>
              <p:spPr>
                <a:xfrm>
                  <a:off x="1771606" y="4922780"/>
                  <a:ext cx="144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4" name="直線接點 203">
                  <a:extLst>
                    <a:ext uri="{FF2B5EF4-FFF2-40B4-BE49-F238E27FC236}">
                      <a16:creationId xmlns="" xmlns:a16="http://schemas.microsoft.com/office/drawing/2014/main" id="{DBD1622B-13BC-DA4C-AC6E-FB3FB774D7FD}"/>
                    </a:ext>
                  </a:extLst>
                </p:cNvPr>
                <p:cNvCxnSpPr/>
                <p:nvPr/>
              </p:nvCxnSpPr>
              <p:spPr>
                <a:xfrm>
                  <a:off x="1943018" y="4922780"/>
                  <a:ext cx="144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直線接點 204">
                  <a:extLst>
                    <a:ext uri="{FF2B5EF4-FFF2-40B4-BE49-F238E27FC236}">
                      <a16:creationId xmlns="" xmlns:a16="http://schemas.microsoft.com/office/drawing/2014/main" id="{4AD2FDC7-564A-754A-934D-76510EE4360C}"/>
                    </a:ext>
                  </a:extLst>
                </p:cNvPr>
                <p:cNvCxnSpPr/>
                <p:nvPr/>
              </p:nvCxnSpPr>
              <p:spPr>
                <a:xfrm>
                  <a:off x="2108261" y="4922780"/>
                  <a:ext cx="144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6" name="文字方塊 205">
                  <a:extLst>
                    <a:ext uri="{FF2B5EF4-FFF2-40B4-BE49-F238E27FC236}">
                      <a16:creationId xmlns="" xmlns:a16="http://schemas.microsoft.com/office/drawing/2014/main" id="{4DF9B962-7DF7-B04F-BE2E-853A9DB8B490}"/>
                    </a:ext>
                  </a:extLst>
                </p:cNvPr>
                <p:cNvSpPr txBox="1"/>
                <p:nvPr/>
              </p:nvSpPr>
              <p:spPr>
                <a:xfrm>
                  <a:off x="2166533" y="4472294"/>
                  <a:ext cx="714491" cy="8309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TW" sz="1600" dirty="0">
                      <a:latin typeface="Arial" charset="0"/>
                      <a:ea typeface="Arial" charset="0"/>
                      <a:cs typeface="Arial" charset="0"/>
                    </a:rPr>
                    <a:t>SR</a:t>
                  </a:r>
                </a:p>
                <a:p>
                  <a:r>
                    <a:rPr kumimoji="1" lang="en-US" altLang="zh-TW" sz="1600" dirty="0">
                      <a:latin typeface="Arial" charset="0"/>
                      <a:ea typeface="Arial" charset="0"/>
                      <a:cs typeface="Arial" charset="0"/>
                    </a:rPr>
                    <a:t>RFA</a:t>
                  </a:r>
                </a:p>
                <a:p>
                  <a:r>
                    <a:rPr kumimoji="1" lang="en-US" altLang="zh-TW" sz="1600" dirty="0">
                      <a:latin typeface="Arial" charset="0"/>
                      <a:ea typeface="Arial" charset="0"/>
                      <a:cs typeface="Arial" charset="0"/>
                    </a:rPr>
                    <a:t>TACE</a:t>
                  </a:r>
                  <a:endParaRPr kumimoji="1" lang="zh-TW" altLang="en-US" sz="16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07" name="直線接點 206">
                  <a:extLst>
                    <a:ext uri="{FF2B5EF4-FFF2-40B4-BE49-F238E27FC236}">
                      <a16:creationId xmlns="" xmlns:a16="http://schemas.microsoft.com/office/drawing/2014/main" id="{8FBB1442-3238-8548-8D8C-3FE07AACB08C}"/>
                    </a:ext>
                  </a:extLst>
                </p:cNvPr>
                <p:cNvCxnSpPr/>
                <p:nvPr/>
              </p:nvCxnSpPr>
              <p:spPr>
                <a:xfrm>
                  <a:off x="1781206" y="5234590"/>
                  <a:ext cx="471055" cy="0"/>
                </a:xfrm>
                <a:prstGeom prst="line">
                  <a:avLst/>
                </a:prstGeom>
                <a:ln w="28575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3" name="群組 192">
                <a:extLst>
                  <a:ext uri="{FF2B5EF4-FFF2-40B4-BE49-F238E27FC236}">
                    <a16:creationId xmlns="" xmlns:a16="http://schemas.microsoft.com/office/drawing/2014/main" id="{E139B06E-E6EF-714C-8BED-57271C915F1E}"/>
                  </a:ext>
                </a:extLst>
              </p:cNvPr>
              <p:cNvGrpSpPr/>
              <p:nvPr/>
            </p:nvGrpSpPr>
            <p:grpSpPr>
              <a:xfrm>
                <a:off x="2332630" y="4878567"/>
                <a:ext cx="298396" cy="687579"/>
                <a:chOff x="5727061" y="1224486"/>
                <a:chExt cx="298396" cy="687579"/>
              </a:xfrm>
            </p:grpSpPr>
            <p:sp>
              <p:nvSpPr>
                <p:cNvPr id="198" name="右中括弧 197">
                  <a:extLst>
                    <a:ext uri="{FF2B5EF4-FFF2-40B4-BE49-F238E27FC236}">
                      <a16:creationId xmlns="" xmlns:a16="http://schemas.microsoft.com/office/drawing/2014/main" id="{28F4180D-0CE4-284E-9E37-0019289E8046}"/>
                    </a:ext>
                  </a:extLst>
                </p:cNvPr>
                <p:cNvSpPr/>
                <p:nvPr/>
              </p:nvSpPr>
              <p:spPr>
                <a:xfrm>
                  <a:off x="5727061" y="1228065"/>
                  <a:ext cx="72000" cy="684000"/>
                </a:xfrm>
                <a:prstGeom prst="rightBracket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TW" altLang="en-US" sz="1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99" name="右中括弧 198">
                  <a:extLst>
                    <a:ext uri="{FF2B5EF4-FFF2-40B4-BE49-F238E27FC236}">
                      <a16:creationId xmlns="" xmlns:a16="http://schemas.microsoft.com/office/drawing/2014/main" id="{93C17A76-032E-5E46-945B-916687E2261C}"/>
                    </a:ext>
                  </a:extLst>
                </p:cNvPr>
                <p:cNvSpPr/>
                <p:nvPr/>
              </p:nvSpPr>
              <p:spPr>
                <a:xfrm>
                  <a:off x="5885461" y="1224486"/>
                  <a:ext cx="67996" cy="468000"/>
                </a:xfrm>
                <a:prstGeom prst="rightBracket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TW" altLang="en-US" sz="1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00" name="直線接點 199">
                  <a:extLst>
                    <a:ext uri="{FF2B5EF4-FFF2-40B4-BE49-F238E27FC236}">
                      <a16:creationId xmlns="" xmlns:a16="http://schemas.microsoft.com/office/drawing/2014/main" id="{3E8DC7B7-819B-314A-84B0-39F1A5C14B09}"/>
                    </a:ext>
                  </a:extLst>
                </p:cNvPr>
                <p:cNvCxnSpPr/>
                <p:nvPr/>
              </p:nvCxnSpPr>
              <p:spPr>
                <a:xfrm flipV="1">
                  <a:off x="5809457" y="1856090"/>
                  <a:ext cx="216000" cy="214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直線接點 200">
                  <a:extLst>
                    <a:ext uri="{FF2B5EF4-FFF2-40B4-BE49-F238E27FC236}">
                      <a16:creationId xmlns="" xmlns:a16="http://schemas.microsoft.com/office/drawing/2014/main" id="{A2B439A1-2382-6C45-8527-C0416F4EC4C1}"/>
                    </a:ext>
                  </a:extLst>
                </p:cNvPr>
                <p:cNvCxnSpPr/>
                <p:nvPr/>
              </p:nvCxnSpPr>
              <p:spPr>
                <a:xfrm flipV="1">
                  <a:off x="5953457" y="1551535"/>
                  <a:ext cx="72000" cy="214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4" name="文字方塊 193">
                <a:extLst>
                  <a:ext uri="{FF2B5EF4-FFF2-40B4-BE49-F238E27FC236}">
                    <a16:creationId xmlns="" xmlns:a16="http://schemas.microsoft.com/office/drawing/2014/main" id="{7CDDB746-ECC9-B54E-82F4-C54986C6FF77}"/>
                  </a:ext>
                </a:extLst>
              </p:cNvPr>
              <p:cNvSpPr txBox="1"/>
              <p:nvPr/>
            </p:nvSpPr>
            <p:spPr>
              <a:xfrm>
                <a:off x="2184038" y="4577405"/>
                <a:ext cx="259718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        HR (95%CI),  p-value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5" name="文字方塊 194">
                <a:extLst>
                  <a:ext uri="{FF2B5EF4-FFF2-40B4-BE49-F238E27FC236}">
                    <a16:creationId xmlns="" xmlns:a16="http://schemas.microsoft.com/office/drawing/2014/main" id="{5D93D74C-FD7B-6E42-8016-F7E689C7A568}"/>
                  </a:ext>
                </a:extLst>
              </p:cNvPr>
              <p:cNvSpPr txBox="1"/>
              <p:nvPr/>
            </p:nvSpPr>
            <p:spPr>
              <a:xfrm>
                <a:off x="2603961" y="4758413"/>
                <a:ext cx="24237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6" name="矩形 195">
                <a:extLst>
                  <a:ext uri="{FF2B5EF4-FFF2-40B4-BE49-F238E27FC236}">
                    <a16:creationId xmlns="" xmlns:a16="http://schemas.microsoft.com/office/drawing/2014/main" id="{35B835D8-940B-324D-BEDF-5D203EBAAC4D}"/>
                  </a:ext>
                </a:extLst>
              </p:cNvPr>
              <p:cNvSpPr/>
              <p:nvPr/>
            </p:nvSpPr>
            <p:spPr>
              <a:xfrm>
                <a:off x="2611424" y="5022356"/>
                <a:ext cx="1991251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1.2 (1.1-1.5),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0.041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lang="zh-TW" altLang="en-US" sz="1600" dirty="0">
                  <a:ln>
                    <a:solidFill>
                      <a:schemeClr val="tx1"/>
                    </a:solidFill>
                  </a:ln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7" name="矩形 196">
                <a:extLst>
                  <a:ext uri="{FF2B5EF4-FFF2-40B4-BE49-F238E27FC236}">
                    <a16:creationId xmlns="" xmlns:a16="http://schemas.microsoft.com/office/drawing/2014/main" id="{5637CBAB-335B-A142-8E9A-850140353383}"/>
                  </a:ext>
                </a:extLst>
              </p:cNvPr>
              <p:cNvSpPr/>
              <p:nvPr/>
            </p:nvSpPr>
            <p:spPr>
              <a:xfrm>
                <a:off x="2595026" y="5328579"/>
                <a:ext cx="1939955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1.7 (1.3-2.2),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&lt;.001</a:t>
                </a:r>
                <a:endParaRPr lang="zh-TW" altLang="en-US" sz="1600" dirty="0">
                  <a:ln>
                    <a:solidFill>
                      <a:schemeClr val="tx1"/>
                    </a:solidFill>
                  </a:ln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211" name="群組 210"/>
          <p:cNvGrpSpPr/>
          <p:nvPr/>
        </p:nvGrpSpPr>
        <p:grpSpPr>
          <a:xfrm>
            <a:off x="731995" y="6732672"/>
            <a:ext cx="7799592" cy="6403084"/>
            <a:chOff x="217066" y="345125"/>
            <a:chExt cx="7731810" cy="6403084"/>
          </a:xfrm>
        </p:grpSpPr>
        <p:sp>
          <p:nvSpPr>
            <p:cNvPr id="212" name="文字方塊 211"/>
            <p:cNvSpPr txBox="1"/>
            <p:nvPr/>
          </p:nvSpPr>
          <p:spPr>
            <a:xfrm>
              <a:off x="217066" y="345125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2400" dirty="0">
                  <a:latin typeface="Arial" charset="0"/>
                  <a:ea typeface="Arial" charset="0"/>
                  <a:cs typeface="Arial" charset="0"/>
                </a:rPr>
                <a:t>C</a:t>
              </a:r>
              <a:endParaRPr kumimoji="1" lang="en-US" altLang="zh-TW" sz="24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13" name="群組 212"/>
            <p:cNvGrpSpPr/>
            <p:nvPr/>
          </p:nvGrpSpPr>
          <p:grpSpPr>
            <a:xfrm>
              <a:off x="263136" y="871476"/>
              <a:ext cx="7685740" cy="5876733"/>
              <a:chOff x="263136" y="871476"/>
              <a:chExt cx="7685740" cy="5876733"/>
            </a:xfrm>
          </p:grpSpPr>
          <p:pic>
            <p:nvPicPr>
              <p:cNvPr id="239" name="圖片 238"/>
              <p:cNvPicPr>
                <a:picLocks noChangeAspect="1"/>
              </p:cNvPicPr>
              <p:nvPr/>
            </p:nvPicPr>
            <p:blipFill rotWithShape="1">
              <a:blip r:embed="rId5"/>
              <a:srcRect l="5776" t="7170" r="25360" b="10612"/>
              <a:stretch/>
            </p:blipFill>
            <p:spPr>
              <a:xfrm>
                <a:off x="641276" y="871476"/>
                <a:ext cx="7307600" cy="5461000"/>
              </a:xfrm>
              <a:prstGeom prst="rect">
                <a:avLst/>
              </a:prstGeom>
            </p:spPr>
          </p:pic>
          <p:sp>
            <p:nvSpPr>
              <p:cNvPr id="240" name="文字方塊 239"/>
              <p:cNvSpPr txBox="1"/>
              <p:nvPr/>
            </p:nvSpPr>
            <p:spPr>
              <a:xfrm rot="10800000">
                <a:off x="263136" y="1571931"/>
                <a:ext cx="492443" cy="42884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txBody>
              <a:bodyPr rot="0" spcFirstLastPara="0" vert="eaVert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altLang="zh-TW" sz="2000" kern="100" dirty="0">
                    <a:latin typeface="Arial" charset="0"/>
                    <a:ea typeface="Arial" charset="0"/>
                    <a:cs typeface="Arial" charset="0"/>
                  </a:rPr>
                  <a:t>O</a:t>
                </a:r>
                <a:r>
                  <a:rPr lang="en-US" sz="2000" kern="100" dirty="0">
                    <a:latin typeface="Arial" charset="0"/>
                    <a:ea typeface="Arial" charset="0"/>
                    <a:cs typeface="Arial" charset="0"/>
                  </a:rPr>
                  <a:t>verall survival (%)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41" name="文字方塊 240"/>
              <p:cNvSpPr txBox="1"/>
              <p:nvPr/>
            </p:nvSpPr>
            <p:spPr>
              <a:xfrm>
                <a:off x="2432470" y="6332476"/>
                <a:ext cx="3907930" cy="41573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Follow up time (months) </a:t>
                </a:r>
                <a:r>
                  <a:rPr lang="zh-TW" altLang="en-US" sz="2000" kern="1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lang="zh-TW" sz="2000" kern="1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14" name="群組 213"/>
            <p:cNvGrpSpPr/>
            <p:nvPr/>
          </p:nvGrpSpPr>
          <p:grpSpPr>
            <a:xfrm>
              <a:off x="3347864" y="1081312"/>
              <a:ext cx="4115872" cy="1406711"/>
              <a:chOff x="4070849" y="900052"/>
              <a:chExt cx="4115872" cy="1406711"/>
            </a:xfrm>
          </p:grpSpPr>
          <p:grpSp>
            <p:nvGrpSpPr>
              <p:cNvPr id="215" name="群組 214"/>
              <p:cNvGrpSpPr/>
              <p:nvPr/>
            </p:nvGrpSpPr>
            <p:grpSpPr>
              <a:xfrm>
                <a:off x="4070849" y="1121441"/>
                <a:ext cx="1461501" cy="1077218"/>
                <a:chOff x="1709977" y="4238400"/>
                <a:chExt cx="1461501" cy="1077218"/>
              </a:xfrm>
            </p:grpSpPr>
            <p:grpSp>
              <p:nvGrpSpPr>
                <p:cNvPr id="228" name="群組 227"/>
                <p:cNvGrpSpPr/>
                <p:nvPr/>
              </p:nvGrpSpPr>
              <p:grpSpPr>
                <a:xfrm>
                  <a:off x="1709977" y="4238400"/>
                  <a:ext cx="1461501" cy="1077218"/>
                  <a:chOff x="1771606" y="4472294"/>
                  <a:chExt cx="1461501" cy="1077218"/>
                </a:xfrm>
              </p:grpSpPr>
              <p:cxnSp>
                <p:nvCxnSpPr>
                  <p:cNvPr id="233" name="直線接點 232"/>
                  <p:cNvCxnSpPr/>
                  <p:nvPr/>
                </p:nvCxnSpPr>
                <p:spPr>
                  <a:xfrm>
                    <a:off x="1781206" y="4641126"/>
                    <a:ext cx="471055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4" name="直線接點 233"/>
                  <p:cNvCxnSpPr/>
                  <p:nvPr/>
                </p:nvCxnSpPr>
                <p:spPr>
                  <a:xfrm>
                    <a:off x="1771606" y="4922780"/>
                    <a:ext cx="144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5" name="直線接點 234"/>
                  <p:cNvCxnSpPr/>
                  <p:nvPr/>
                </p:nvCxnSpPr>
                <p:spPr>
                  <a:xfrm>
                    <a:off x="1943018" y="4922780"/>
                    <a:ext cx="144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6" name="直線接點 235"/>
                  <p:cNvCxnSpPr/>
                  <p:nvPr/>
                </p:nvCxnSpPr>
                <p:spPr>
                  <a:xfrm>
                    <a:off x="2108261" y="4922780"/>
                    <a:ext cx="144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7" name="文字方塊 236"/>
                  <p:cNvSpPr txBox="1"/>
                  <p:nvPr/>
                </p:nvSpPr>
                <p:spPr>
                  <a:xfrm>
                    <a:off x="2252261" y="4472294"/>
                    <a:ext cx="980846" cy="107721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zh-TW" sz="1600" dirty="0">
                        <a:latin typeface="Arial" charset="0"/>
                        <a:ea typeface="Arial" charset="0"/>
                        <a:cs typeface="Arial" charset="0"/>
                      </a:rPr>
                      <a:t>SR</a:t>
                    </a:r>
                  </a:p>
                  <a:p>
                    <a:r>
                      <a:rPr kumimoji="1" lang="en-US" altLang="zh-TW" sz="1600" dirty="0">
                        <a:latin typeface="Arial" charset="0"/>
                        <a:ea typeface="Arial" charset="0"/>
                        <a:cs typeface="Arial" charset="0"/>
                      </a:rPr>
                      <a:t>RFA</a:t>
                    </a:r>
                  </a:p>
                  <a:p>
                    <a:r>
                      <a:rPr kumimoji="1" lang="en-US" altLang="zh-TW" sz="1600" dirty="0">
                        <a:latin typeface="Arial" charset="0"/>
                        <a:ea typeface="Arial" charset="0"/>
                        <a:cs typeface="Arial" charset="0"/>
                      </a:rPr>
                      <a:t>TACE</a:t>
                    </a:r>
                  </a:p>
                  <a:p>
                    <a:r>
                      <a:rPr kumimoji="1" lang="en-US" altLang="zh-TW" sz="1600" dirty="0">
                        <a:latin typeface="Arial" charset="0"/>
                        <a:ea typeface="Arial" charset="0"/>
                        <a:cs typeface="Arial" charset="0"/>
                      </a:rPr>
                      <a:t>Other</a:t>
                    </a:r>
                    <a:r>
                      <a:rPr kumimoji="1" lang="zh-TW" altLang="en-US" sz="1600" dirty="0">
                        <a:latin typeface="Arial" charset="0"/>
                        <a:ea typeface="Arial" charset="0"/>
                        <a:cs typeface="Arial" charset="0"/>
                      </a:rPr>
                      <a:t> </a:t>
                    </a:r>
                    <a:r>
                      <a:rPr kumimoji="1" lang="en-US" altLang="zh-TW" sz="1600" dirty="0" err="1">
                        <a:latin typeface="Arial" charset="0"/>
                        <a:ea typeface="Arial" charset="0"/>
                        <a:cs typeface="Arial" charset="0"/>
                      </a:rPr>
                      <a:t>Tx</a:t>
                    </a:r>
                    <a:endParaRPr kumimoji="1" lang="zh-TW" altLang="en-US" sz="1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238" name="直線接點 237"/>
                  <p:cNvCxnSpPr/>
                  <p:nvPr/>
                </p:nvCxnSpPr>
                <p:spPr>
                  <a:xfrm>
                    <a:off x="1781206" y="5234590"/>
                    <a:ext cx="471055" cy="0"/>
                  </a:xfrm>
                  <a:prstGeom prst="line">
                    <a:avLst/>
                  </a:prstGeom>
                  <a:ln w="28575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9" name="群組 228"/>
                <p:cNvGrpSpPr/>
                <p:nvPr/>
              </p:nvGrpSpPr>
              <p:grpSpPr>
                <a:xfrm>
                  <a:off x="1713061" y="5239319"/>
                  <a:ext cx="480655" cy="0"/>
                  <a:chOff x="1851619" y="4819771"/>
                  <a:chExt cx="480655" cy="0"/>
                </a:xfrm>
              </p:grpSpPr>
              <p:cxnSp>
                <p:nvCxnSpPr>
                  <p:cNvPr id="230" name="直線接點 229"/>
                  <p:cNvCxnSpPr/>
                  <p:nvPr/>
                </p:nvCxnSpPr>
                <p:spPr>
                  <a:xfrm>
                    <a:off x="1851619" y="4819771"/>
                    <a:ext cx="144000" cy="0"/>
                  </a:xfrm>
                  <a:prstGeom prst="line">
                    <a:avLst/>
                  </a:prstGeom>
                  <a:ln w="28575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1" name="直線接點 230"/>
                  <p:cNvCxnSpPr/>
                  <p:nvPr/>
                </p:nvCxnSpPr>
                <p:spPr>
                  <a:xfrm>
                    <a:off x="2023031" y="4819771"/>
                    <a:ext cx="144000" cy="0"/>
                  </a:xfrm>
                  <a:prstGeom prst="line">
                    <a:avLst/>
                  </a:prstGeom>
                  <a:ln w="28575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直線接點 231"/>
                  <p:cNvCxnSpPr/>
                  <p:nvPr/>
                </p:nvCxnSpPr>
                <p:spPr>
                  <a:xfrm>
                    <a:off x="2188274" y="4819771"/>
                    <a:ext cx="144000" cy="0"/>
                  </a:xfrm>
                  <a:prstGeom prst="line">
                    <a:avLst/>
                  </a:prstGeom>
                  <a:ln w="28575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16" name="群組 215"/>
              <p:cNvGrpSpPr/>
              <p:nvPr/>
            </p:nvGrpSpPr>
            <p:grpSpPr>
              <a:xfrm>
                <a:off x="5511951" y="1215245"/>
                <a:ext cx="454208" cy="1008000"/>
                <a:chOff x="6201123" y="1094932"/>
                <a:chExt cx="454208" cy="1008000"/>
              </a:xfrm>
            </p:grpSpPr>
            <p:sp>
              <p:nvSpPr>
                <p:cNvPr id="222" name="右中括弧 221"/>
                <p:cNvSpPr/>
                <p:nvPr/>
              </p:nvSpPr>
              <p:spPr>
                <a:xfrm>
                  <a:off x="6201123" y="1094932"/>
                  <a:ext cx="72000" cy="1008000"/>
                </a:xfrm>
                <a:prstGeom prst="rightBracket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TW" altLang="en-US" sz="1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3" name="右中括弧 222"/>
                <p:cNvSpPr/>
                <p:nvPr/>
              </p:nvSpPr>
              <p:spPr>
                <a:xfrm>
                  <a:off x="6356935" y="1101559"/>
                  <a:ext cx="72000" cy="720000"/>
                </a:xfrm>
                <a:prstGeom prst="rightBracket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TW" altLang="en-US" sz="1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4" name="右中括弧 223"/>
                <p:cNvSpPr/>
                <p:nvPr/>
              </p:nvSpPr>
              <p:spPr>
                <a:xfrm>
                  <a:off x="6515335" y="1097980"/>
                  <a:ext cx="72000" cy="396000"/>
                </a:xfrm>
                <a:prstGeom prst="rightBracket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TW" altLang="en-US" sz="1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25" name="直線接點 224"/>
                <p:cNvCxnSpPr/>
                <p:nvPr/>
              </p:nvCxnSpPr>
              <p:spPr>
                <a:xfrm>
                  <a:off x="6277090" y="2047725"/>
                  <a:ext cx="324000" cy="75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直線接點 225"/>
                <p:cNvCxnSpPr/>
                <p:nvPr/>
              </p:nvCxnSpPr>
              <p:spPr>
                <a:xfrm flipV="1">
                  <a:off x="6439331" y="1741159"/>
                  <a:ext cx="216000" cy="214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直線接點 226"/>
                <p:cNvCxnSpPr/>
                <p:nvPr/>
              </p:nvCxnSpPr>
              <p:spPr>
                <a:xfrm flipV="1">
                  <a:off x="6582028" y="1406349"/>
                  <a:ext cx="72000" cy="214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7" name="文字方塊 216"/>
              <p:cNvSpPr txBox="1"/>
              <p:nvPr/>
            </p:nvSpPr>
            <p:spPr>
              <a:xfrm>
                <a:off x="5531827" y="900052"/>
                <a:ext cx="265489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        HR (95%CI),   p-value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8" name="文字方塊 217"/>
              <p:cNvSpPr txBox="1"/>
              <p:nvPr/>
            </p:nvSpPr>
            <p:spPr>
              <a:xfrm>
                <a:off x="5951750" y="1095348"/>
                <a:ext cx="24237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endParaRPr kumimoji="1"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9" name="矩形 218"/>
              <p:cNvSpPr/>
              <p:nvPr/>
            </p:nvSpPr>
            <p:spPr>
              <a:xfrm>
                <a:off x="5964856" y="1368551"/>
                <a:ext cx="1933543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1.4 (1.1-2.2),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0.043</a:t>
                </a:r>
                <a:endParaRPr lang="zh-TW" altLang="en-US" sz="1600" dirty="0">
                  <a:ln>
                    <a:solidFill>
                      <a:schemeClr val="tx1"/>
                    </a:solidFill>
                  </a:ln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20" name="矩形 219"/>
              <p:cNvSpPr/>
              <p:nvPr/>
            </p:nvSpPr>
            <p:spPr>
              <a:xfrm>
                <a:off x="5951750" y="1663070"/>
                <a:ext cx="1939955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1.7 (1.3-2.2),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&lt;.001</a:t>
                </a:r>
                <a:endParaRPr lang="zh-TW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21" name="矩形 220"/>
              <p:cNvSpPr/>
              <p:nvPr/>
            </p:nvSpPr>
            <p:spPr>
              <a:xfrm>
                <a:off x="5956142" y="1968209"/>
                <a:ext cx="1939955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2.3 (1.7-3.3),</a:t>
                </a:r>
                <a:r>
                  <a:rPr kumimoji="1" lang="zh-TW" altLang="en-US" sz="1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kumimoji="1" lang="en-US" altLang="zh-TW" sz="1600" dirty="0">
                    <a:latin typeface="Arial" charset="0"/>
                    <a:ea typeface="Arial" charset="0"/>
                    <a:cs typeface="Arial" charset="0"/>
                  </a:rPr>
                  <a:t>&lt;.001</a:t>
                </a:r>
                <a:endParaRPr lang="zh-TW" altLang="en-US" sz="1600" dirty="0">
                  <a:ln>
                    <a:solidFill>
                      <a:schemeClr val="tx1"/>
                    </a:solidFill>
                  </a:ln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503100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73</TotalTime>
  <Words>158</Words>
  <Application>Microsoft Macintosh PowerPoint</Application>
  <PresentationFormat>自訂</PresentationFormat>
  <Paragraphs>5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新細明體</vt:lpstr>
      <vt:lpstr>Arial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李煜嬋</dc:creator>
  <cp:lastModifiedBy>Microsoft Office 使用者</cp:lastModifiedBy>
  <cp:revision>22</cp:revision>
  <dcterms:created xsi:type="dcterms:W3CDTF">2018-09-12T02:56:07Z</dcterms:created>
  <dcterms:modified xsi:type="dcterms:W3CDTF">2021-03-21T06:46:13Z</dcterms:modified>
</cp:coreProperties>
</file>